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7199313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0" autoAdjust="0"/>
    <p:restoredTop sz="94660"/>
  </p:normalViewPr>
  <p:slideViewPr>
    <p:cSldViewPr snapToGrid="0">
      <p:cViewPr>
        <p:scale>
          <a:sx n="75" d="100"/>
          <a:sy n="75" d="100"/>
        </p:scale>
        <p:origin x="104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119505"/>
            <a:ext cx="6119416" cy="2381521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592866"/>
            <a:ext cx="5399485" cy="1651546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0840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3985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64195"/>
            <a:ext cx="1552352" cy="5797040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64195"/>
            <a:ext cx="4567064" cy="5797040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23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220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705386"/>
            <a:ext cx="6209407" cy="2845473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4577779"/>
            <a:ext cx="6209407" cy="149636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4047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820976"/>
            <a:ext cx="3059708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820976"/>
            <a:ext cx="3059708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80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64197"/>
            <a:ext cx="6209407" cy="1322188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676882"/>
            <a:ext cx="3045646" cy="82181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498697"/>
            <a:ext cx="3045646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676882"/>
            <a:ext cx="3060646" cy="82181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498697"/>
            <a:ext cx="3060646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7754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5778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222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6036"/>
            <a:ext cx="2321966" cy="1596126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984912"/>
            <a:ext cx="3644652" cy="4861216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2161"/>
            <a:ext cx="2321966" cy="3801883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0563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6036"/>
            <a:ext cx="2321966" cy="1596126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984912"/>
            <a:ext cx="3644652" cy="4861216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2161"/>
            <a:ext cx="2321966" cy="3801883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369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64197"/>
            <a:ext cx="6209407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820976"/>
            <a:ext cx="6209407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6340167"/>
            <a:ext cx="161984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6340167"/>
            <a:ext cx="242976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6340167"/>
            <a:ext cx="161984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9710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>
            <a:extLst>
              <a:ext uri="{FF2B5EF4-FFF2-40B4-BE49-F238E27FC236}">
                <a16:creationId xmlns:a16="http://schemas.microsoft.com/office/drawing/2014/main" id="{199C3F21-AABA-BD62-5415-8DEC4191449A}"/>
              </a:ext>
            </a:extLst>
          </p:cNvPr>
          <p:cNvSpPr txBox="1"/>
          <p:nvPr/>
        </p:nvSpPr>
        <p:spPr>
          <a:xfrm>
            <a:off x="252352" y="158063"/>
            <a:ext cx="66946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3: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sability of App “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Concep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”: Positive and negative aspects of the app usage and suggestions for improvement ranked according to number of times mentioned (Tm) by patients.</a:t>
            </a:r>
            <a:endParaRPr lang="de-DE" sz="12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12" name="Tabelle 11">
            <a:extLst>
              <a:ext uri="{FF2B5EF4-FFF2-40B4-BE49-F238E27FC236}">
                <a16:creationId xmlns:a16="http://schemas.microsoft.com/office/drawing/2014/main" id="{735A2DE1-7955-12E1-9883-92DFA38C0A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4469962"/>
              </p:ext>
            </p:extLst>
          </p:nvPr>
        </p:nvGraphicFramePr>
        <p:xfrm>
          <a:off x="352377" y="693019"/>
          <a:ext cx="6594582" cy="5910985"/>
        </p:xfrm>
        <a:graphic>
          <a:graphicData uri="http://schemas.openxmlformats.org/drawingml/2006/table">
            <a:tbl>
              <a:tblPr/>
              <a:tblGrid>
                <a:gridCol w="1616882">
                  <a:extLst>
                    <a:ext uri="{9D8B030D-6E8A-4147-A177-3AD203B41FA5}">
                      <a16:colId xmlns:a16="http://schemas.microsoft.com/office/drawing/2014/main" val="590011923"/>
                    </a:ext>
                  </a:extLst>
                </a:gridCol>
                <a:gridCol w="292323">
                  <a:extLst>
                    <a:ext uri="{9D8B030D-6E8A-4147-A177-3AD203B41FA5}">
                      <a16:colId xmlns:a16="http://schemas.microsoft.com/office/drawing/2014/main" val="803574124"/>
                    </a:ext>
                  </a:extLst>
                </a:gridCol>
                <a:gridCol w="1977302">
                  <a:extLst>
                    <a:ext uri="{9D8B030D-6E8A-4147-A177-3AD203B41FA5}">
                      <a16:colId xmlns:a16="http://schemas.microsoft.com/office/drawing/2014/main" val="1403778313"/>
                    </a:ext>
                  </a:extLst>
                </a:gridCol>
                <a:gridCol w="230215">
                  <a:extLst>
                    <a:ext uri="{9D8B030D-6E8A-4147-A177-3AD203B41FA5}">
                      <a16:colId xmlns:a16="http://schemas.microsoft.com/office/drawing/2014/main" val="3193181744"/>
                    </a:ext>
                  </a:extLst>
                </a:gridCol>
                <a:gridCol w="2197575">
                  <a:extLst>
                    <a:ext uri="{9D8B030D-6E8A-4147-A177-3AD203B41FA5}">
                      <a16:colId xmlns:a16="http://schemas.microsoft.com/office/drawing/2014/main" val="2394197247"/>
                    </a:ext>
                  </a:extLst>
                </a:gridCol>
                <a:gridCol w="280285">
                  <a:extLst>
                    <a:ext uri="{9D8B030D-6E8A-4147-A177-3AD203B41FA5}">
                      <a16:colId xmlns:a16="http://schemas.microsoft.com/office/drawing/2014/main" val="1020547141"/>
                    </a:ext>
                  </a:extLst>
                </a:gridCol>
              </a:tblGrid>
              <a:tr h="41602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asons</a:t>
                      </a:r>
                      <a:r>
                        <a:rPr lang="de-DE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</a:t>
                      </a:r>
                      <a:r>
                        <a:rPr lang="de-DE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aining</a:t>
                      </a:r>
                      <a:r>
                        <a:rPr lang="it-IT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top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m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vantages of app-based training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m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uggestions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1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m</a:t>
                      </a:r>
                      <a:endParaRPr lang="de-DE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026609"/>
                  </a:ext>
                </a:extLst>
              </a:tr>
              <a:tr h="56148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Trained but not shown (in Backend)/no data transfer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"Obligation" to do it every day/Routine/Motivation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fr-FR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mment box </a:t>
                      </a:r>
                      <a:r>
                        <a:rPr lang="fr-FR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fter</a:t>
                      </a:r>
                      <a:r>
                        <a:rPr lang="fr-FR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ily</a:t>
                      </a:r>
                      <a:r>
                        <a:rPr lang="fr-FR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questionnaire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5961322"/>
                  </a:ext>
                </a:extLst>
              </a:tr>
              <a:tr h="3572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chincal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ssu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provement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bility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e able to see more than last 5d of     training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0987141"/>
                  </a:ext>
                </a:extLst>
              </a:tr>
              <a:tr h="47750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ealth reasons (non-related to training)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tretching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Videos: Possibility to turn around and zoom in, or play on tablet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6918600"/>
                  </a:ext>
                </a:extLst>
              </a:tr>
              <a:tr h="41964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vid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ccination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bility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to adjust training according to personal wish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etter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udio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2451245"/>
                  </a:ext>
                </a:extLst>
              </a:tr>
              <a:tr h="56148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ccation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Daily Feedback possible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lay all exercises automatically with adjustable break in between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383048"/>
                  </a:ext>
                </a:extLst>
              </a:tr>
              <a:tr h="3572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Visitor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emporarilly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aetially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dependent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ore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vanced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ercis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0423717"/>
                  </a:ext>
                </a:extLst>
              </a:tr>
              <a:tr h="41964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Not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nchronized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mall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ffort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ossibility to skip introduction of video after 1st time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5590455"/>
                  </a:ext>
                </a:extLst>
              </a:tr>
              <a:tr h="2778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o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usy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Wide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ange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ercis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ossibility to watch other videos as well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6273066"/>
                  </a:ext>
                </a:extLst>
              </a:tr>
              <a:tr h="2778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ental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provement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ore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ariety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ercis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0697988"/>
                  </a:ext>
                </a:extLst>
              </a:tr>
              <a:tr h="2778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Direct contact to therapist possible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minder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do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raining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984466"/>
                  </a:ext>
                </a:extLst>
              </a:tr>
              <a:tr h="3572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oft start into training after diagnosis 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Possibility to choose order of exercis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7198388"/>
                  </a:ext>
                </a:extLst>
              </a:tr>
              <a:tr h="2778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Whole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ody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ercise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ore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ailed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questionnaire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3657668"/>
                  </a:ext>
                </a:extLst>
              </a:tr>
              <a:tr h="2778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eing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ercises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deos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peed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pp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7797772"/>
                  </a:ext>
                </a:extLst>
              </a:tr>
              <a:tr h="2370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More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ailed</a:t>
                      </a: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deos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5058611"/>
                  </a:ext>
                </a:extLst>
              </a:tr>
              <a:tr h="357276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de-DE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horter training periods till adjustment 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de-DE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769" marR="3769" marT="3769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45807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83869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292</Words>
  <Application>Microsoft Office PowerPoint</Application>
  <PresentationFormat>Benutzerdefiniert</PresentationFormat>
  <Paragraphs>7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ützow, Lisa</dc:creator>
  <cp:lastModifiedBy>Lützow, Lisa</cp:lastModifiedBy>
  <cp:revision>4</cp:revision>
  <dcterms:created xsi:type="dcterms:W3CDTF">2023-02-16T07:37:04Z</dcterms:created>
  <dcterms:modified xsi:type="dcterms:W3CDTF">2023-02-16T07:50:29Z</dcterms:modified>
</cp:coreProperties>
</file>